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8.jpeg" ContentType="image/jpeg"/>
  <Override PartName="/ppt/media/image5.png" ContentType="image/png"/>
  <Override PartName="/ppt/media/image6.png" ContentType="image/png"/>
  <Override PartName="/ppt/media/image7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0AE911-1232-44D8-93AC-1FC96A4503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E1B54A-170D-48D2-B328-2A09E96544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BAF34B-C088-4B1C-A32D-74EC2A0DEC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D891EB-BB6D-4AD9-A4FF-808E62ADAE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7A004A-D365-452E-982F-03BB1B8AAB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58142C-7E02-42E6-89C5-BDE7E34B37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7402D3-BC01-4059-88D7-60878C2EF4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6458C4-6FFF-471A-B3C0-E8D1F32F38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9054B6-B788-4E30-88D3-D5FFAAE23F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6BAA9-22DD-421C-A548-A3A6D6CE22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74DEE-558E-4068-8C87-240AD22666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4DEFE-0C41-4F6D-A807-FA43FD523E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064CDB-AE80-41BF-983A-B4F6D1CBFDFA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49"/>
          <p:cNvGrpSpPr/>
          <p:nvPr/>
        </p:nvGrpSpPr>
        <p:grpSpPr>
          <a:xfrm>
            <a:off x="3915000" y="282600"/>
            <a:ext cx="5121000" cy="4370040"/>
            <a:chOff x="3915000" y="282600"/>
            <a:chExt cx="5121000" cy="4370040"/>
          </a:xfrm>
        </p:grpSpPr>
        <p:sp>
          <p:nvSpPr>
            <p:cNvPr id="42" name="テキスト ボックス 7"/>
            <p:cNvSpPr/>
            <p:nvPr/>
          </p:nvSpPr>
          <p:spPr>
            <a:xfrm>
              <a:off x="3915000" y="282600"/>
              <a:ext cx="7354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r>
                <a:rPr b="0" lang="ja-JP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　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グループ化 49"/>
            <p:cNvGrpSpPr/>
            <p:nvPr/>
          </p:nvGrpSpPr>
          <p:grpSpPr>
            <a:xfrm>
              <a:off x="4369320" y="2176560"/>
              <a:ext cx="4257720" cy="532440"/>
              <a:chOff x="4369320" y="2176560"/>
              <a:chExt cx="4257720" cy="532440"/>
            </a:xfrm>
          </p:grpSpPr>
          <p:pic>
            <p:nvPicPr>
              <p:cNvPr id="44" name="図 2" descr="b actin 2min.tif"/>
              <p:cNvPicPr/>
              <p:nvPr/>
            </p:nvPicPr>
            <p:blipFill>
              <a:blip r:embed="rId1">
                <a:lum bright="20000"/>
              </a:blip>
              <a:srcRect l="0" t="54223" r="0" b="23205"/>
              <a:stretch/>
            </p:blipFill>
            <p:spPr>
              <a:xfrm>
                <a:off x="5251680" y="2176560"/>
                <a:ext cx="3375360" cy="532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Text Box 17"/>
              <p:cNvSpPr/>
              <p:nvPr/>
            </p:nvSpPr>
            <p:spPr>
              <a:xfrm>
                <a:off x="4369320" y="2392560"/>
                <a:ext cx="85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明朝"/>
                  </a:rPr>
                  <a:t>beta-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Text Box 384"/>
              <p:cNvSpPr/>
              <p:nvPr/>
            </p:nvSpPr>
            <p:spPr>
              <a:xfrm>
                <a:off x="4964760" y="2298960"/>
                <a:ext cx="351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7" name="グループ化 54"/>
            <p:cNvGrpSpPr/>
            <p:nvPr/>
          </p:nvGrpSpPr>
          <p:grpSpPr>
            <a:xfrm>
              <a:off x="4440960" y="2870640"/>
              <a:ext cx="4595040" cy="1782000"/>
              <a:chOff x="4440960" y="2870640"/>
              <a:chExt cx="4595040" cy="1782000"/>
            </a:xfrm>
          </p:grpSpPr>
          <p:pic>
            <p:nvPicPr>
              <p:cNvPr id="48" name="図 28" descr="Nkx2.1 Tm58,1-1-2,35cycle.bmp"/>
              <p:cNvPicPr/>
              <p:nvPr/>
            </p:nvPicPr>
            <p:blipFill>
              <a:blip r:embed="rId2"/>
              <a:srcRect l="9839" t="32677" r="18107" b="57882"/>
              <a:stretch/>
            </p:blipFill>
            <p:spPr>
              <a:xfrm>
                <a:off x="5282280" y="3003840"/>
                <a:ext cx="3753720" cy="319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9" name="図 29" descr="b actin Tm58,1-1-2,35cycle.bmp"/>
              <p:cNvPicPr/>
              <p:nvPr/>
            </p:nvPicPr>
            <p:blipFill>
              <a:blip r:embed="rId3"/>
              <a:srcRect l="9449" t="28354" r="18496" b="63780"/>
              <a:stretch/>
            </p:blipFill>
            <p:spPr>
              <a:xfrm>
                <a:off x="5271120" y="3369600"/>
                <a:ext cx="3753720" cy="266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0" name="Text Box 17"/>
              <p:cNvSpPr/>
              <p:nvPr/>
            </p:nvSpPr>
            <p:spPr>
              <a:xfrm>
                <a:off x="4469040" y="3070440"/>
                <a:ext cx="656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明朝"/>
                  </a:rPr>
                  <a:t>Nkx2.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Text Box 17"/>
              <p:cNvSpPr/>
              <p:nvPr/>
            </p:nvSpPr>
            <p:spPr>
              <a:xfrm>
                <a:off x="4440960" y="3351600"/>
                <a:ext cx="85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明朝"/>
                  </a:rPr>
                  <a:t>beta-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2" name="グループ化 46"/>
              <p:cNvGrpSpPr/>
              <p:nvPr/>
            </p:nvGrpSpPr>
            <p:grpSpPr>
              <a:xfrm>
                <a:off x="5601240" y="3331800"/>
                <a:ext cx="3350160" cy="1320840"/>
                <a:chOff x="5601240" y="3331800"/>
                <a:chExt cx="3350160" cy="1320840"/>
              </a:xfrm>
            </p:grpSpPr>
            <p:sp>
              <p:nvSpPr>
                <p:cNvPr id="53" name="Text Box 17"/>
                <p:cNvSpPr/>
                <p:nvPr/>
              </p:nvSpPr>
              <p:spPr>
                <a:xfrm rot="16200000">
                  <a:off x="7815960" y="3853800"/>
                  <a:ext cx="13208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明朝"/>
                    </a:rPr>
                    <a:t>NCI-H66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Text Box 17"/>
                <p:cNvSpPr/>
                <p:nvPr/>
              </p:nvSpPr>
              <p:spPr>
                <a:xfrm flipH="1" rot="16200000">
                  <a:off x="5313240" y="3740760"/>
                  <a:ext cx="852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明朝"/>
                    </a:rPr>
                    <a:t>AZ52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Text Box 17"/>
                <p:cNvSpPr/>
                <p:nvPr/>
              </p:nvSpPr>
              <p:spPr>
                <a:xfrm rot="16200000">
                  <a:off x="6010200" y="3709080"/>
                  <a:ext cx="852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明朝"/>
                    </a:rPr>
                    <a:t>SH1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Text Box 17"/>
                <p:cNvSpPr/>
                <p:nvPr/>
              </p:nvSpPr>
              <p:spPr>
                <a:xfrm rot="16200000">
                  <a:off x="5667120" y="3723120"/>
                  <a:ext cx="852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明朝"/>
                    </a:rPr>
                    <a:t>GCIY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Text Box 17"/>
                <p:cNvSpPr/>
                <p:nvPr/>
              </p:nvSpPr>
              <p:spPr>
                <a:xfrm rot="16200000">
                  <a:off x="6333840" y="3799440"/>
                  <a:ext cx="852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明朝"/>
                    </a:rPr>
                    <a:t>NUGC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Text Box 17"/>
                <p:cNvSpPr/>
                <p:nvPr/>
              </p:nvSpPr>
              <p:spPr>
                <a:xfrm rot="16200000">
                  <a:off x="7365960" y="3723120"/>
                  <a:ext cx="852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明朝"/>
                    </a:rPr>
                    <a:t>MKN7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Text Box 17"/>
                <p:cNvSpPr/>
                <p:nvPr/>
              </p:nvSpPr>
              <p:spPr>
                <a:xfrm rot="16200000">
                  <a:off x="7707240" y="3799440"/>
                  <a:ext cx="852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明朝"/>
                    </a:rPr>
                    <a:t>MKN7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Text Box 17"/>
                <p:cNvSpPr/>
                <p:nvPr/>
              </p:nvSpPr>
              <p:spPr>
                <a:xfrm rot="16200000">
                  <a:off x="6676920" y="3799440"/>
                  <a:ext cx="852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明朝"/>
                    </a:rPr>
                    <a:t>Kato III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Text Box 17"/>
                <p:cNvSpPr/>
                <p:nvPr/>
              </p:nvSpPr>
              <p:spPr>
                <a:xfrm rot="16200000">
                  <a:off x="7016760" y="3709080"/>
                  <a:ext cx="852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明朝"/>
                    </a:rPr>
                    <a:t>KE97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Text Box 17"/>
                <p:cNvSpPr/>
                <p:nvPr/>
              </p:nvSpPr>
              <p:spPr>
                <a:xfrm rot="16200000">
                  <a:off x="8386920" y="3709080"/>
                  <a:ext cx="852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明朝"/>
                    </a:rPr>
                    <a:t>DW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3" name="Text Box 384"/>
              <p:cNvSpPr/>
              <p:nvPr/>
            </p:nvSpPr>
            <p:spPr>
              <a:xfrm>
                <a:off x="4917600" y="287064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p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4" name="グループ化 63"/>
            <p:cNvGrpSpPr/>
            <p:nvPr/>
          </p:nvGrpSpPr>
          <p:grpSpPr>
            <a:xfrm>
              <a:off x="4374720" y="693000"/>
              <a:ext cx="4661280" cy="1409760"/>
              <a:chOff x="4374720" y="693000"/>
              <a:chExt cx="4661280" cy="1409760"/>
            </a:xfrm>
          </p:grpSpPr>
          <p:sp>
            <p:nvSpPr>
              <p:cNvPr id="65" name="Text Box 384"/>
              <p:cNvSpPr/>
              <p:nvPr/>
            </p:nvSpPr>
            <p:spPr>
              <a:xfrm>
                <a:off x="4827960" y="693000"/>
                <a:ext cx="497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kD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6" name="グループ化 52"/>
              <p:cNvGrpSpPr/>
              <p:nvPr/>
            </p:nvGrpSpPr>
            <p:grpSpPr>
              <a:xfrm>
                <a:off x="4374720" y="877680"/>
                <a:ext cx="4255920" cy="1225080"/>
                <a:chOff x="4374720" y="877680"/>
                <a:chExt cx="4255920" cy="1225080"/>
              </a:xfrm>
            </p:grpSpPr>
            <p:sp>
              <p:nvSpPr>
                <p:cNvPr id="67" name="Text Box 384"/>
                <p:cNvSpPr/>
                <p:nvPr/>
              </p:nvSpPr>
              <p:spPr>
                <a:xfrm>
                  <a:off x="4886640" y="923040"/>
                  <a:ext cx="5047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5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Text Box 384"/>
                <p:cNvSpPr/>
                <p:nvPr/>
              </p:nvSpPr>
              <p:spPr>
                <a:xfrm>
                  <a:off x="4952520" y="1169640"/>
                  <a:ext cx="3513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4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Text Box 384"/>
                <p:cNvSpPr/>
                <p:nvPr/>
              </p:nvSpPr>
              <p:spPr>
                <a:xfrm>
                  <a:off x="4955400" y="1423080"/>
                  <a:ext cx="3513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Text Box 384"/>
                <p:cNvSpPr/>
                <p:nvPr/>
              </p:nvSpPr>
              <p:spPr>
                <a:xfrm>
                  <a:off x="4952520" y="1763280"/>
                  <a:ext cx="3513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71" name="グループ化 47"/>
                <p:cNvGrpSpPr/>
                <p:nvPr/>
              </p:nvGrpSpPr>
              <p:grpSpPr>
                <a:xfrm>
                  <a:off x="4374720" y="877680"/>
                  <a:ext cx="4255920" cy="1225080"/>
                  <a:chOff x="4374720" y="877680"/>
                  <a:chExt cx="4255920" cy="1225080"/>
                </a:xfrm>
              </p:grpSpPr>
              <p:pic>
                <p:nvPicPr>
                  <p:cNvPr id="72" name="図 26" descr="Nkx2.1 nuclear 10min.tif"/>
                  <p:cNvPicPr/>
                  <p:nvPr/>
                </p:nvPicPr>
                <p:blipFill>
                  <a:blip r:embed="rId4"/>
                  <a:srcRect l="0" t="46089" r="100" b="7842"/>
                  <a:stretch/>
                </p:blipFill>
                <p:spPr>
                  <a:xfrm>
                    <a:off x="5258520" y="877680"/>
                    <a:ext cx="3372120" cy="1225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73" name="Text Box 17"/>
                  <p:cNvSpPr/>
                  <p:nvPr/>
                </p:nvSpPr>
                <p:spPr>
                  <a:xfrm>
                    <a:off x="4374720" y="1393560"/>
                    <a:ext cx="6562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Arial"/>
                        <a:ea typeface="ＭＳ 明朝"/>
                      </a:rPr>
                      <a:t>Nkx2.1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74" name="左矢印 20"/>
              <p:cNvSpPr/>
              <p:nvPr/>
            </p:nvSpPr>
            <p:spPr>
              <a:xfrm>
                <a:off x="8624880" y="1172880"/>
                <a:ext cx="411120" cy="160200"/>
              </a:xfrm>
              <a:prstGeom prst="leftArrow">
                <a:avLst>
                  <a:gd name="adj1" fmla="val 50000"/>
                  <a:gd name="adj2" fmla="val 52882"/>
                </a:avLst>
              </a:prstGeom>
              <a:solidFill>
                <a:srgbClr val="000000"/>
              </a:solidFill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480" bIns="334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5" name="Text Box 17"/>
            <p:cNvSpPr/>
            <p:nvPr/>
          </p:nvSpPr>
          <p:spPr>
            <a:xfrm>
              <a:off x="4143240" y="836640"/>
              <a:ext cx="467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ＭＳ 明朝"/>
                </a:rPr>
                <a:t>W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17"/>
            <p:cNvSpPr/>
            <p:nvPr/>
          </p:nvSpPr>
          <p:spPr>
            <a:xfrm>
              <a:off x="4138920" y="2708280"/>
              <a:ext cx="851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ＭＳ 明朝"/>
                </a:rPr>
                <a:t>RT-PC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" name="グループ化 59"/>
          <p:cNvGrpSpPr/>
          <p:nvPr/>
        </p:nvGrpSpPr>
        <p:grpSpPr>
          <a:xfrm>
            <a:off x="-60120" y="282600"/>
            <a:ext cx="4998960" cy="3553200"/>
            <a:chOff x="-60120" y="282600"/>
            <a:chExt cx="4998960" cy="3553200"/>
          </a:xfrm>
        </p:grpSpPr>
        <p:sp>
          <p:nvSpPr>
            <p:cNvPr id="78" name="テキスト ボックス 75"/>
            <p:cNvSpPr/>
            <p:nvPr/>
          </p:nvSpPr>
          <p:spPr>
            <a:xfrm>
              <a:off x="-60120" y="282600"/>
              <a:ext cx="6652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　</a:t>
              </a: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9" name="グループ化 77"/>
            <p:cNvGrpSpPr/>
            <p:nvPr/>
          </p:nvGrpSpPr>
          <p:grpSpPr>
            <a:xfrm>
              <a:off x="192600" y="666360"/>
              <a:ext cx="4746240" cy="3009240"/>
              <a:chOff x="192600" y="666360"/>
              <a:chExt cx="4746240" cy="3009240"/>
            </a:xfrm>
          </p:grpSpPr>
          <p:pic>
            <p:nvPicPr>
              <p:cNvPr id="80" name="グラフ 84" descr=""/>
              <p:cNvPicPr/>
              <p:nvPr/>
            </p:nvPicPr>
            <p:blipFill>
              <a:blip r:embed="rId5"/>
              <a:stretch/>
            </p:blipFill>
            <p:spPr>
              <a:xfrm>
                <a:off x="359640" y="927000"/>
                <a:ext cx="4579200" cy="2748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1" name="テキスト ボックス 85"/>
              <p:cNvSpPr/>
              <p:nvPr/>
            </p:nvSpPr>
            <p:spPr>
              <a:xfrm>
                <a:off x="192600" y="666360"/>
                <a:ext cx="4154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(%)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82" name="グラフ 86" descr=""/>
              <p:cNvPicPr/>
              <p:nvPr/>
            </p:nvPicPr>
            <p:blipFill>
              <a:blip r:embed="rId6"/>
              <a:stretch/>
            </p:blipFill>
            <p:spPr>
              <a:xfrm>
                <a:off x="316800" y="890280"/>
                <a:ext cx="4335120" cy="27486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83" name="テキスト ボックス 79"/>
            <p:cNvSpPr/>
            <p:nvPr/>
          </p:nvSpPr>
          <p:spPr>
            <a:xfrm>
              <a:off x="733680" y="3559320"/>
              <a:ext cx="57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5/17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テキスト ボックス 80"/>
            <p:cNvSpPr/>
            <p:nvPr/>
          </p:nvSpPr>
          <p:spPr>
            <a:xfrm>
              <a:off x="1313280" y="3559320"/>
              <a:ext cx="57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7/3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テキスト ボックス 81"/>
            <p:cNvSpPr/>
            <p:nvPr/>
          </p:nvSpPr>
          <p:spPr>
            <a:xfrm>
              <a:off x="1962720" y="3559320"/>
              <a:ext cx="57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3/2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テキスト ボックス 82"/>
            <p:cNvSpPr/>
            <p:nvPr/>
          </p:nvSpPr>
          <p:spPr>
            <a:xfrm>
              <a:off x="2682000" y="3556080"/>
              <a:ext cx="57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1/1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テキスト ボックス 83"/>
            <p:cNvSpPr/>
            <p:nvPr/>
          </p:nvSpPr>
          <p:spPr>
            <a:xfrm>
              <a:off x="3331440" y="3558240"/>
              <a:ext cx="57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0/1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" name="グループ化 16"/>
          <p:cNvGrpSpPr/>
          <p:nvPr/>
        </p:nvGrpSpPr>
        <p:grpSpPr>
          <a:xfrm>
            <a:off x="326520" y="4170240"/>
            <a:ext cx="8277840" cy="2478240"/>
            <a:chOff x="326520" y="4170240"/>
            <a:chExt cx="8277840" cy="2478240"/>
          </a:xfrm>
        </p:grpSpPr>
        <p:sp>
          <p:nvSpPr>
            <p:cNvPr id="89" name="テキスト ボックス 47"/>
            <p:cNvSpPr/>
            <p:nvPr/>
          </p:nvSpPr>
          <p:spPr>
            <a:xfrm>
              <a:off x="326520" y="4170240"/>
              <a:ext cx="3650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384"/>
            <p:cNvSpPr/>
            <p:nvPr/>
          </p:nvSpPr>
          <p:spPr>
            <a:xfrm>
              <a:off x="4294080" y="4659120"/>
              <a:ext cx="138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. primary tumo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1" name="グループ化 13"/>
            <p:cNvGrpSpPr/>
            <p:nvPr/>
          </p:nvGrpSpPr>
          <p:grpSpPr>
            <a:xfrm>
              <a:off x="3167640" y="4593960"/>
              <a:ext cx="2734920" cy="2054520"/>
              <a:chOff x="3167640" y="4593960"/>
              <a:chExt cx="2734920" cy="2054520"/>
            </a:xfrm>
          </p:grpSpPr>
          <p:pic>
            <p:nvPicPr>
              <p:cNvPr id="92" name="図 3" descr="IV3P x20.jpg"/>
              <p:cNvPicPr/>
              <p:nvPr/>
            </p:nvPicPr>
            <p:blipFill>
              <a:blip r:embed="rId7"/>
              <a:stretch/>
            </p:blipFill>
            <p:spPr>
              <a:xfrm>
                <a:off x="3228120" y="4593960"/>
                <a:ext cx="2674440" cy="2054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3" name="直線コネクタ 64"/>
              <p:cNvSpPr/>
              <p:nvPr/>
            </p:nvSpPr>
            <p:spPr>
              <a:xfrm>
                <a:off x="5151600" y="6542280"/>
                <a:ext cx="699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Text Box 384"/>
              <p:cNvSpPr/>
              <p:nvPr/>
            </p:nvSpPr>
            <p:spPr>
              <a:xfrm>
                <a:off x="3167640" y="4598640"/>
                <a:ext cx="2160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. Peritoneal disseminat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5" name="グループ化 72"/>
            <p:cNvGrpSpPr/>
            <p:nvPr/>
          </p:nvGrpSpPr>
          <p:grpSpPr>
            <a:xfrm>
              <a:off x="484920" y="4591800"/>
              <a:ext cx="2707560" cy="2056680"/>
              <a:chOff x="484920" y="4591800"/>
              <a:chExt cx="2707560" cy="2056680"/>
            </a:xfrm>
          </p:grpSpPr>
          <p:pic>
            <p:nvPicPr>
              <p:cNvPr id="96" name="図 4" descr="IV7T x20.jpg"/>
              <p:cNvPicPr/>
              <p:nvPr/>
            </p:nvPicPr>
            <p:blipFill>
              <a:blip r:embed="rId8">
                <a:lum bright="20000"/>
              </a:blip>
              <a:stretch/>
            </p:blipFill>
            <p:spPr>
              <a:xfrm>
                <a:off x="518040" y="4593600"/>
                <a:ext cx="2674440" cy="2054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7" name="直線コネクタ 5"/>
              <p:cNvSpPr/>
              <p:nvPr/>
            </p:nvSpPr>
            <p:spPr>
              <a:xfrm>
                <a:off x="2428560" y="6545520"/>
                <a:ext cx="699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Text Box 384"/>
              <p:cNvSpPr/>
              <p:nvPr/>
            </p:nvSpPr>
            <p:spPr>
              <a:xfrm>
                <a:off x="484920" y="4591800"/>
                <a:ext cx="1386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 primary tumo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9" name="グループ化 15"/>
            <p:cNvGrpSpPr/>
            <p:nvPr/>
          </p:nvGrpSpPr>
          <p:grpSpPr>
            <a:xfrm>
              <a:off x="5928120" y="4581000"/>
              <a:ext cx="2676240" cy="2056320"/>
              <a:chOff x="5928120" y="4581000"/>
              <a:chExt cx="2676240" cy="2056320"/>
            </a:xfrm>
          </p:grpSpPr>
          <p:grpSp>
            <p:nvGrpSpPr>
              <p:cNvPr id="100" name="グループ化 11"/>
              <p:cNvGrpSpPr/>
              <p:nvPr/>
            </p:nvGrpSpPr>
            <p:grpSpPr>
              <a:xfrm>
                <a:off x="5928120" y="4581000"/>
                <a:ext cx="2676240" cy="2056320"/>
                <a:chOff x="5928120" y="4581000"/>
                <a:chExt cx="2676240" cy="2056320"/>
              </a:xfrm>
            </p:grpSpPr>
            <p:pic>
              <p:nvPicPr>
                <p:cNvPr id="101" name="図 2" descr="positive contorol x40.jpg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5942880" y="4592520"/>
                  <a:ext cx="2661480" cy="20448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02" name="Text Box 384"/>
                <p:cNvSpPr/>
                <p:nvPr/>
              </p:nvSpPr>
              <p:spPr>
                <a:xfrm>
                  <a:off x="5928120" y="4581000"/>
                  <a:ext cx="14882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. positive control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3" name="直線コネクタ 87"/>
              <p:cNvSpPr/>
              <p:nvPr/>
            </p:nvSpPr>
            <p:spPr>
              <a:xfrm>
                <a:off x="7847280" y="6540840"/>
                <a:ext cx="699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09T22:06:24Z</dcterms:created>
  <dc:creator>Keishi Yamashita</dc:creator>
  <dc:description/>
  <dc:language>en-US</dc:language>
  <cp:lastModifiedBy>外科</cp:lastModifiedBy>
  <dcterms:modified xsi:type="dcterms:W3CDTF">2014-08-07T08:24:10Z</dcterms:modified>
  <cp:revision>37</cp:revision>
  <dc:subject/>
  <dc:title>PowerPoint プレゼンテーション</dc:title>
</cp:coreProperties>
</file>